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50D502-C656-4FE4-9C05-CAD999D3FA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138D94-6FF2-494F-84D5-C3C0B6AD99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DDCC2-4338-46E5-B307-75E04D9C38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4EB09-D8E4-4BAC-BFEF-16BFDBF263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88DA0-CA16-4EF4-9FD1-9F0ED0961B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2430B-5732-4697-AA3D-3E4924B824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B0AEA-C667-48F5-B019-4C9C6FD22F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EC4F8-9415-4B44-A5C4-ECAF3E0EB8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C3A40-94AD-44A3-AFCA-A1113AE354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5E524-11B5-4F58-8B21-D4A4709489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D06C7-6A45-4A1C-8977-A9B03844AC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389FD-107A-41A1-8FAD-727A1CEA07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C63503-CAEB-4958-8F22-7B13B5ADBBAA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192"/>
          <p:cNvSpPr/>
          <p:nvPr/>
        </p:nvSpPr>
        <p:spPr>
          <a:xfrm>
            <a:off x="4773600" y="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CasellaDiTesto 1"/>
          <p:cNvSpPr/>
          <p:nvPr/>
        </p:nvSpPr>
        <p:spPr>
          <a:xfrm>
            <a:off x="398520" y="6705720"/>
            <a:ext cx="58672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3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olvement of the oxidative stress in the response of iPrEC cells to Doxo and DTX treatment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low cytometric evaluation of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ROS generation and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apoptosis, carried out in the drug-exposed iPrEC cells, previously loaded with NAC agent.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Analysis of ROS production performed in Doxo- and DTX-treated iPrEC transfectant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uppo 2"/>
          <p:cNvGrpSpPr/>
          <p:nvPr/>
        </p:nvGrpSpPr>
        <p:grpSpPr>
          <a:xfrm>
            <a:off x="304920" y="657360"/>
            <a:ext cx="2945520" cy="2189520"/>
            <a:chOff x="304920" y="657360"/>
            <a:chExt cx="2945520" cy="2189520"/>
          </a:xfrm>
        </p:grpSpPr>
        <p:grpSp>
          <p:nvGrpSpPr>
            <p:cNvPr id="44" name="Gruppo 29"/>
            <p:cNvGrpSpPr/>
            <p:nvPr/>
          </p:nvGrpSpPr>
          <p:grpSpPr>
            <a:xfrm>
              <a:off x="598320" y="931680"/>
              <a:ext cx="2266920" cy="1454040"/>
              <a:chOff x="598320" y="931680"/>
              <a:chExt cx="2266920" cy="1454040"/>
            </a:xfrm>
          </p:grpSpPr>
          <p:pic>
            <p:nvPicPr>
              <p:cNvPr id="45" name="Grafico 3" descr=""/>
              <p:cNvPicPr/>
              <p:nvPr/>
            </p:nvPicPr>
            <p:blipFill>
              <a:blip r:embed="rId1"/>
              <a:stretch/>
            </p:blipFill>
            <p:spPr>
              <a:xfrm>
                <a:off x="840960" y="931680"/>
                <a:ext cx="2024280" cy="1454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CasellaDiTesto 402"/>
              <p:cNvSpPr/>
              <p:nvPr/>
            </p:nvSpPr>
            <p:spPr>
              <a:xfrm rot="16200000">
                <a:off x="419760" y="1567440"/>
                <a:ext cx="603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% RO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7" name="Text Box 474"/>
            <p:cNvSpPr/>
            <p:nvPr/>
          </p:nvSpPr>
          <p:spPr>
            <a:xfrm>
              <a:off x="304920" y="65736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CasellaDiTesto 5"/>
            <p:cNvSpPr/>
            <p:nvPr/>
          </p:nvSpPr>
          <p:spPr>
            <a:xfrm>
              <a:off x="1667520" y="83340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iPrE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9" name="Gruppo 1"/>
            <p:cNvGrpSpPr/>
            <p:nvPr/>
          </p:nvGrpSpPr>
          <p:grpSpPr>
            <a:xfrm>
              <a:off x="1083240" y="2274840"/>
              <a:ext cx="2167200" cy="572040"/>
              <a:chOff x="1083240" y="2274840"/>
              <a:chExt cx="2167200" cy="572040"/>
            </a:xfrm>
          </p:grpSpPr>
          <p:grpSp>
            <p:nvGrpSpPr>
              <p:cNvPr id="50" name="Gruppo 22"/>
              <p:cNvGrpSpPr/>
              <p:nvPr/>
            </p:nvGrpSpPr>
            <p:grpSpPr>
              <a:xfrm>
                <a:off x="1201680" y="2274840"/>
                <a:ext cx="2048760" cy="257040"/>
                <a:chOff x="1201680" y="2274840"/>
                <a:chExt cx="2048760" cy="257040"/>
              </a:xfrm>
            </p:grpSpPr>
            <p:sp>
              <p:nvSpPr>
                <p:cNvPr id="51" name="CasellaDiTesto 343"/>
                <p:cNvSpPr/>
                <p:nvPr/>
              </p:nvSpPr>
              <p:spPr>
                <a:xfrm>
                  <a:off x="1201680" y="2274840"/>
                  <a:ext cx="258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-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CasellaDiTesto 344"/>
                <p:cNvSpPr/>
                <p:nvPr/>
              </p:nvSpPr>
              <p:spPr>
                <a:xfrm>
                  <a:off x="1343160" y="2280960"/>
                  <a:ext cx="324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+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CasellaDiTesto 389"/>
                <p:cNvSpPr/>
                <p:nvPr/>
              </p:nvSpPr>
              <p:spPr>
                <a:xfrm>
                  <a:off x="1784160" y="2274840"/>
                  <a:ext cx="258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-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CasellaDiTesto 390"/>
                <p:cNvSpPr/>
                <p:nvPr/>
              </p:nvSpPr>
              <p:spPr>
                <a:xfrm>
                  <a:off x="1902960" y="2285640"/>
                  <a:ext cx="324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+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CasellaDiTesto 394"/>
                <p:cNvSpPr/>
                <p:nvPr/>
              </p:nvSpPr>
              <p:spPr>
                <a:xfrm>
                  <a:off x="2348640" y="2274840"/>
                  <a:ext cx="258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-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CasellaDiTesto 395"/>
                <p:cNvSpPr/>
                <p:nvPr/>
              </p:nvSpPr>
              <p:spPr>
                <a:xfrm>
                  <a:off x="2474640" y="2284200"/>
                  <a:ext cx="324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+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CasellaDiTesto 400"/>
                <p:cNvSpPr/>
                <p:nvPr/>
              </p:nvSpPr>
              <p:spPr>
                <a:xfrm>
                  <a:off x="2854800" y="2310840"/>
                  <a:ext cx="395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800" spc="-1" strike="noStrike">
                      <a:solidFill>
                        <a:srgbClr val="000000"/>
                      </a:solidFill>
                      <a:latin typeface="Arial"/>
                    </a:rPr>
                    <a:t>NAC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8" name="CasellaDiTesto 401"/>
              <p:cNvSpPr/>
              <p:nvPr/>
            </p:nvSpPr>
            <p:spPr>
              <a:xfrm>
                <a:off x="1667160" y="2509560"/>
                <a:ext cx="6195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Dox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(0,75 µM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Connettore 1 31"/>
              <p:cNvSpPr/>
              <p:nvPr/>
            </p:nvSpPr>
            <p:spPr>
              <a:xfrm>
                <a:off x="1169640" y="2511360"/>
                <a:ext cx="457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Connettore 1 32"/>
              <p:cNvSpPr/>
              <p:nvPr/>
            </p:nvSpPr>
            <p:spPr>
              <a:xfrm>
                <a:off x="1785960" y="2511360"/>
                <a:ext cx="457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Connettore 1 33"/>
              <p:cNvSpPr/>
              <p:nvPr/>
            </p:nvSpPr>
            <p:spPr>
              <a:xfrm>
                <a:off x="2368800" y="2511360"/>
                <a:ext cx="457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CasellaDiTesto 401"/>
              <p:cNvSpPr/>
              <p:nvPr/>
            </p:nvSpPr>
            <p:spPr>
              <a:xfrm>
                <a:off x="2342520" y="2509560"/>
                <a:ext cx="531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DTX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(10 nM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CasellaDiTesto 401"/>
              <p:cNvSpPr/>
              <p:nvPr/>
            </p:nvSpPr>
            <p:spPr>
              <a:xfrm>
                <a:off x="1083240" y="2509560"/>
                <a:ext cx="627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Untre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4" name="Gruppo 1"/>
          <p:cNvGrpSpPr/>
          <p:nvPr/>
        </p:nvGrpSpPr>
        <p:grpSpPr>
          <a:xfrm>
            <a:off x="3375000" y="603360"/>
            <a:ext cx="2939040" cy="2283480"/>
            <a:chOff x="3375000" y="603360"/>
            <a:chExt cx="2939040" cy="2283480"/>
          </a:xfrm>
        </p:grpSpPr>
        <p:grpSp>
          <p:nvGrpSpPr>
            <p:cNvPr id="65" name="Gruppo 30"/>
            <p:cNvGrpSpPr/>
            <p:nvPr/>
          </p:nvGrpSpPr>
          <p:grpSpPr>
            <a:xfrm>
              <a:off x="3514680" y="961920"/>
              <a:ext cx="2421000" cy="1447920"/>
              <a:chOff x="3514680" y="961920"/>
              <a:chExt cx="2421000" cy="1447920"/>
            </a:xfrm>
          </p:grpSpPr>
          <p:pic>
            <p:nvPicPr>
              <p:cNvPr id="66" name="Grafico 4" descr=""/>
              <p:cNvPicPr/>
              <p:nvPr/>
            </p:nvPicPr>
            <p:blipFill>
              <a:blip r:embed="rId2"/>
              <a:stretch/>
            </p:blipFill>
            <p:spPr>
              <a:xfrm>
                <a:off x="3913200" y="961920"/>
                <a:ext cx="2022480" cy="1447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7" name="CasellaDiTesto 402"/>
              <p:cNvSpPr/>
              <p:nvPr/>
            </p:nvSpPr>
            <p:spPr>
              <a:xfrm rot="16200000">
                <a:off x="3112920" y="1503000"/>
                <a:ext cx="120168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% Apoptosi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(Ann V+/PI- cells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" name="Gruppo 1"/>
            <p:cNvGrpSpPr/>
            <p:nvPr/>
          </p:nvGrpSpPr>
          <p:grpSpPr>
            <a:xfrm>
              <a:off x="4147200" y="2314800"/>
              <a:ext cx="2166840" cy="572040"/>
              <a:chOff x="4147200" y="2314800"/>
              <a:chExt cx="2166840" cy="572040"/>
            </a:xfrm>
          </p:grpSpPr>
          <p:grpSp>
            <p:nvGrpSpPr>
              <p:cNvPr id="69" name="Gruppo 22"/>
              <p:cNvGrpSpPr/>
              <p:nvPr/>
            </p:nvGrpSpPr>
            <p:grpSpPr>
              <a:xfrm>
                <a:off x="4265640" y="2314800"/>
                <a:ext cx="2048400" cy="257040"/>
                <a:chOff x="4265640" y="2314800"/>
                <a:chExt cx="2048400" cy="257040"/>
              </a:xfrm>
            </p:grpSpPr>
            <p:sp>
              <p:nvSpPr>
                <p:cNvPr id="70" name="CasellaDiTesto 343"/>
                <p:cNvSpPr/>
                <p:nvPr/>
              </p:nvSpPr>
              <p:spPr>
                <a:xfrm>
                  <a:off x="4265640" y="2314800"/>
                  <a:ext cx="258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-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CasellaDiTesto 344"/>
                <p:cNvSpPr/>
                <p:nvPr/>
              </p:nvSpPr>
              <p:spPr>
                <a:xfrm>
                  <a:off x="4407120" y="2320920"/>
                  <a:ext cx="324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+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CasellaDiTesto 389"/>
                <p:cNvSpPr/>
                <p:nvPr/>
              </p:nvSpPr>
              <p:spPr>
                <a:xfrm>
                  <a:off x="4848120" y="2314800"/>
                  <a:ext cx="258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-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CasellaDiTesto 390"/>
                <p:cNvSpPr/>
                <p:nvPr/>
              </p:nvSpPr>
              <p:spPr>
                <a:xfrm>
                  <a:off x="4966920" y="2325600"/>
                  <a:ext cx="324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+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CasellaDiTesto 394"/>
                <p:cNvSpPr/>
                <p:nvPr/>
              </p:nvSpPr>
              <p:spPr>
                <a:xfrm>
                  <a:off x="5412600" y="2314800"/>
                  <a:ext cx="258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-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CasellaDiTesto 395"/>
                <p:cNvSpPr/>
                <p:nvPr/>
              </p:nvSpPr>
              <p:spPr>
                <a:xfrm>
                  <a:off x="5538600" y="2324160"/>
                  <a:ext cx="324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+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CasellaDiTesto 400"/>
                <p:cNvSpPr/>
                <p:nvPr/>
              </p:nvSpPr>
              <p:spPr>
                <a:xfrm>
                  <a:off x="5918400" y="2350800"/>
                  <a:ext cx="395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800" spc="-1" strike="noStrike">
                      <a:solidFill>
                        <a:srgbClr val="000000"/>
                      </a:solidFill>
                      <a:latin typeface="Arial"/>
                    </a:rPr>
                    <a:t>NAC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7" name="CasellaDiTesto 401"/>
              <p:cNvSpPr/>
              <p:nvPr/>
            </p:nvSpPr>
            <p:spPr>
              <a:xfrm>
                <a:off x="4731120" y="2549520"/>
                <a:ext cx="6195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Dox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(0,75 µM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Connettore 1 24"/>
              <p:cNvSpPr/>
              <p:nvPr/>
            </p:nvSpPr>
            <p:spPr>
              <a:xfrm>
                <a:off x="4233600" y="2551320"/>
                <a:ext cx="457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Connettore 1 25"/>
              <p:cNvSpPr/>
              <p:nvPr/>
            </p:nvSpPr>
            <p:spPr>
              <a:xfrm>
                <a:off x="4849560" y="2551320"/>
                <a:ext cx="457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Connettore 1 26"/>
              <p:cNvSpPr/>
              <p:nvPr/>
            </p:nvSpPr>
            <p:spPr>
              <a:xfrm>
                <a:off x="5432400" y="2551320"/>
                <a:ext cx="457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CasellaDiTesto 401"/>
              <p:cNvSpPr/>
              <p:nvPr/>
            </p:nvSpPr>
            <p:spPr>
              <a:xfrm>
                <a:off x="5406120" y="2549520"/>
                <a:ext cx="531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DTX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(10 nM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CasellaDiTesto 401"/>
              <p:cNvSpPr/>
              <p:nvPr/>
            </p:nvSpPr>
            <p:spPr>
              <a:xfrm>
                <a:off x="4147200" y="2549520"/>
                <a:ext cx="627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</a:rPr>
                  <a:t>Untreate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3" name="Text Box 474"/>
            <p:cNvSpPr/>
            <p:nvPr/>
          </p:nvSpPr>
          <p:spPr>
            <a:xfrm>
              <a:off x="3375000" y="60336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CasellaDiTesto 5"/>
            <p:cNvSpPr/>
            <p:nvPr/>
          </p:nvSpPr>
          <p:spPr>
            <a:xfrm>
              <a:off x="4732920" y="84924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iPrE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" name="Text Box 474"/>
          <p:cNvSpPr/>
          <p:nvPr/>
        </p:nvSpPr>
        <p:spPr>
          <a:xfrm>
            <a:off x="295200" y="338148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Gruppo 6"/>
          <p:cNvGrpSpPr/>
          <p:nvPr/>
        </p:nvGrpSpPr>
        <p:grpSpPr>
          <a:xfrm>
            <a:off x="990720" y="3429000"/>
            <a:ext cx="4070160" cy="3044880"/>
            <a:chOff x="990720" y="3429000"/>
            <a:chExt cx="4070160" cy="3044880"/>
          </a:xfrm>
        </p:grpSpPr>
        <p:grpSp>
          <p:nvGrpSpPr>
            <p:cNvPr id="87" name="Gruppo 5"/>
            <p:cNvGrpSpPr/>
            <p:nvPr/>
          </p:nvGrpSpPr>
          <p:grpSpPr>
            <a:xfrm>
              <a:off x="990720" y="3557160"/>
              <a:ext cx="3897720" cy="2670480"/>
              <a:chOff x="990720" y="3557160"/>
              <a:chExt cx="3897720" cy="2670480"/>
            </a:xfrm>
          </p:grpSpPr>
          <p:pic>
            <p:nvPicPr>
              <p:cNvPr id="88" name="Picture 44" descr=""/>
              <p:cNvPicPr/>
              <p:nvPr/>
            </p:nvPicPr>
            <p:blipFill>
              <a:blip r:embed="rId3"/>
              <a:stretch/>
            </p:blipFill>
            <p:spPr>
              <a:xfrm>
                <a:off x="990720" y="3557160"/>
                <a:ext cx="1292760" cy="133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9" name="Picture 2" descr=""/>
              <p:cNvPicPr/>
              <p:nvPr/>
            </p:nvPicPr>
            <p:blipFill>
              <a:blip r:embed="rId4"/>
              <a:stretch/>
            </p:blipFill>
            <p:spPr>
              <a:xfrm>
                <a:off x="2297520" y="3557160"/>
                <a:ext cx="1292760" cy="133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0" name="Picture 3" descr=""/>
              <p:cNvPicPr/>
              <p:nvPr/>
            </p:nvPicPr>
            <p:blipFill>
              <a:blip r:embed="rId5"/>
              <a:stretch/>
            </p:blipFill>
            <p:spPr>
              <a:xfrm>
                <a:off x="3595680" y="3557160"/>
                <a:ext cx="1292760" cy="133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1" name="Picture 5" descr=""/>
              <p:cNvPicPr/>
              <p:nvPr/>
            </p:nvPicPr>
            <p:blipFill>
              <a:blip r:embed="rId6"/>
              <a:stretch/>
            </p:blipFill>
            <p:spPr>
              <a:xfrm>
                <a:off x="2297520" y="4894200"/>
                <a:ext cx="1292760" cy="133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2" name="Picture 6" descr=""/>
              <p:cNvPicPr/>
              <p:nvPr/>
            </p:nvPicPr>
            <p:blipFill>
              <a:blip r:embed="rId7"/>
              <a:stretch/>
            </p:blipFill>
            <p:spPr>
              <a:xfrm>
                <a:off x="990720" y="4894200"/>
                <a:ext cx="1292760" cy="1333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3" name="Picture 7" descr=""/>
              <p:cNvPicPr/>
              <p:nvPr/>
            </p:nvPicPr>
            <p:blipFill>
              <a:blip r:embed="rId8"/>
              <a:stretch/>
            </p:blipFill>
            <p:spPr>
              <a:xfrm>
                <a:off x="3595680" y="4894200"/>
                <a:ext cx="1292760" cy="13334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94" name="CasellaDiTesto 401"/>
            <p:cNvSpPr/>
            <p:nvPr/>
          </p:nvSpPr>
          <p:spPr>
            <a:xfrm>
              <a:off x="3976200" y="3429000"/>
              <a:ext cx="59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USP2a</a:t>
              </a:r>
              <a:r>
                <a:rPr b="0" lang="it-IT" sz="8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CasellaDiTesto 401"/>
            <p:cNvSpPr/>
            <p:nvPr/>
          </p:nvSpPr>
          <p:spPr>
            <a:xfrm>
              <a:off x="2645280" y="3429000"/>
              <a:ext cx="63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USP2a</a:t>
              </a:r>
              <a:r>
                <a:rPr b="0" lang="it-IT" sz="800" spc="-1" strike="noStrike" baseline="30000">
                  <a:solidFill>
                    <a:srgbClr val="000000"/>
                  </a:solidFill>
                  <a:latin typeface="Arial"/>
                </a:rPr>
                <a:t>MU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CasellaDiTesto 401"/>
            <p:cNvSpPr/>
            <p:nvPr/>
          </p:nvSpPr>
          <p:spPr>
            <a:xfrm>
              <a:off x="1494360" y="3429000"/>
              <a:ext cx="31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EV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CasellaDiTesto 401"/>
            <p:cNvSpPr/>
            <p:nvPr/>
          </p:nvSpPr>
          <p:spPr>
            <a:xfrm>
              <a:off x="4876200" y="4061880"/>
              <a:ext cx="184680" cy="21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CasellaDiTesto 5"/>
            <p:cNvSpPr/>
            <p:nvPr/>
          </p:nvSpPr>
          <p:spPr>
            <a:xfrm>
              <a:off x="2381040" y="6227640"/>
              <a:ext cx="970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ROS </a:t>
              </a: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gener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" name="Gruppo 14"/>
          <p:cNvGrpSpPr/>
          <p:nvPr/>
        </p:nvGrpSpPr>
        <p:grpSpPr>
          <a:xfrm>
            <a:off x="4981680" y="3557520"/>
            <a:ext cx="1039320" cy="323280"/>
            <a:chOff x="4981680" y="3557520"/>
            <a:chExt cx="1039320" cy="323280"/>
          </a:xfrm>
        </p:grpSpPr>
        <p:sp>
          <p:nvSpPr>
            <p:cNvPr id="100" name="Connettore 1 61"/>
            <p:cNvSpPr/>
            <p:nvPr/>
          </p:nvSpPr>
          <p:spPr>
            <a:xfrm>
              <a:off x="4981680" y="3642840"/>
              <a:ext cx="287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CasellaDiTesto 13"/>
            <p:cNvSpPr/>
            <p:nvPr/>
          </p:nvSpPr>
          <p:spPr>
            <a:xfrm>
              <a:off x="5223960" y="3557520"/>
              <a:ext cx="590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ntreated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Connettore 1 63"/>
            <p:cNvSpPr/>
            <p:nvPr/>
          </p:nvSpPr>
          <p:spPr>
            <a:xfrm>
              <a:off x="4989600" y="3766680"/>
              <a:ext cx="287640" cy="0"/>
            </a:xfrm>
            <a:prstGeom prst="line">
              <a:avLst/>
            </a:prstGeom>
            <a:ln w="64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CasellaDiTesto 50"/>
            <p:cNvSpPr/>
            <p:nvPr/>
          </p:nvSpPr>
          <p:spPr>
            <a:xfrm>
              <a:off x="5233680" y="3680280"/>
              <a:ext cx="787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Doxo (0,75 µM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4" name="Gruppo 14"/>
          <p:cNvGrpSpPr/>
          <p:nvPr/>
        </p:nvGrpSpPr>
        <p:grpSpPr>
          <a:xfrm>
            <a:off x="4971960" y="4876920"/>
            <a:ext cx="932400" cy="323640"/>
            <a:chOff x="4971960" y="4876920"/>
            <a:chExt cx="932400" cy="323640"/>
          </a:xfrm>
        </p:grpSpPr>
        <p:sp>
          <p:nvSpPr>
            <p:cNvPr id="105" name="Connettore 1 68"/>
            <p:cNvSpPr/>
            <p:nvPr/>
          </p:nvSpPr>
          <p:spPr>
            <a:xfrm>
              <a:off x="4971960" y="4962600"/>
              <a:ext cx="286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CasellaDiTesto 13"/>
            <p:cNvSpPr/>
            <p:nvPr/>
          </p:nvSpPr>
          <p:spPr>
            <a:xfrm>
              <a:off x="5212800" y="4876920"/>
              <a:ext cx="590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ntreated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Connettore 1 70"/>
            <p:cNvSpPr/>
            <p:nvPr/>
          </p:nvSpPr>
          <p:spPr>
            <a:xfrm>
              <a:off x="4979880" y="5086800"/>
              <a:ext cx="286920" cy="0"/>
            </a:xfrm>
            <a:prstGeom prst="line">
              <a:avLst/>
            </a:prstGeom>
            <a:ln w="64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CasellaDiTesto 50"/>
            <p:cNvSpPr/>
            <p:nvPr/>
          </p:nvSpPr>
          <p:spPr>
            <a:xfrm>
              <a:off x="5220720" y="5000040"/>
              <a:ext cx="683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DTX (10 nM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14T08:41:35Z</dcterms:created>
  <dc:creator>Barbara</dc:creator>
  <dc:description/>
  <dc:language>en-US</dc:language>
  <cp:lastModifiedBy>BarbaraB</cp:lastModifiedBy>
  <dcterms:modified xsi:type="dcterms:W3CDTF">2013-06-13T10:02:07Z</dcterms:modified>
  <cp:revision>17</cp:revision>
  <dc:subject/>
  <dc:title>Diapositiva 1</dc:title>
</cp:coreProperties>
</file>